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9C009B-1C1E-482E-AE4A-BE66F8E051D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5D0369-C0A5-4AF7-8A7B-FD87D64A9E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6C4F9B-EB5E-4F31-8AD8-57482BF77D5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2C6FD1-0554-473C-8FC4-779B9644ED9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91238A-33B1-458F-BDE7-5CA2ED5D6F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60A42E-4EE9-4AAA-9C5F-F6A7091310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FD4AFB-633F-415B-8FC8-34E2B6EEA2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A12D7B-13D0-4640-BE3E-3794F4E39F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CFE99B-B1E8-43A9-8596-42471DA361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F8BF76-85F1-4706-8DE4-850CB8FDF6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0063B5-BF9E-4E60-BF40-6A17272527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AFB0C3-1AC1-48C3-A830-98CF72A96A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16DFD8-0B5B-4795-A548-11EEF58813A1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5 Imagen" descr="composite WB.tif"/>
          <p:cNvPicPr/>
          <p:nvPr/>
        </p:nvPicPr>
        <p:blipFill>
          <a:blip r:embed="rId1"/>
          <a:srcRect l="0" t="0" r="68410" b="0"/>
          <a:stretch/>
        </p:blipFill>
        <p:spPr>
          <a:xfrm>
            <a:off x="1197000" y="3276720"/>
            <a:ext cx="1701720" cy="1885680"/>
          </a:xfrm>
          <a:prstGeom prst="rect">
            <a:avLst/>
          </a:prstGeom>
          <a:ln w="0">
            <a:noFill/>
          </a:ln>
        </p:spPr>
      </p:pic>
      <p:pic>
        <p:nvPicPr>
          <p:cNvPr id="42" name="6 Imagen" descr="composite WB.tif"/>
          <p:cNvPicPr/>
          <p:nvPr/>
        </p:nvPicPr>
        <p:blipFill>
          <a:blip r:embed="rId2"/>
          <a:srcRect l="64366" t="0" r="0" b="0"/>
          <a:stretch/>
        </p:blipFill>
        <p:spPr>
          <a:xfrm>
            <a:off x="2565360" y="5580000"/>
            <a:ext cx="1878120" cy="1846440"/>
          </a:xfrm>
          <a:prstGeom prst="rect">
            <a:avLst/>
          </a:prstGeom>
          <a:ln w="0">
            <a:noFill/>
          </a:ln>
        </p:spPr>
      </p:pic>
      <p:pic>
        <p:nvPicPr>
          <p:cNvPr id="43" name="22 Gráfico" descr=""/>
          <p:cNvPicPr/>
          <p:nvPr/>
        </p:nvPicPr>
        <p:blipFill>
          <a:blip r:embed="rId3"/>
          <a:stretch/>
        </p:blipFill>
        <p:spPr>
          <a:xfrm>
            <a:off x="615960" y="963720"/>
            <a:ext cx="2571840" cy="2144520"/>
          </a:xfrm>
          <a:prstGeom prst="rect">
            <a:avLst/>
          </a:prstGeom>
          <a:ln w="0">
            <a:noFill/>
          </a:ln>
        </p:spPr>
      </p:pic>
      <p:sp>
        <p:nvSpPr>
          <p:cNvPr id="44" name="13 Rectángulo"/>
          <p:cNvSpPr/>
          <p:nvPr/>
        </p:nvSpPr>
        <p:spPr>
          <a:xfrm>
            <a:off x="115920" y="7723080"/>
            <a:ext cx="6626160" cy="11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8. Overexpression of NUDT16 promotes FBXO28 degradation and MYC deubiquitination in MOLT-16 cells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(a) Overexpression of NUDT16 decreases FBXO28 mRNA (above) and protein levels (below) . (b) Ubiquitination of endogenous MYC protein is decreased following NUDT16 overexpression. Ubiquitination was detected by immunoprecipitation of MYC followed by immunoblotting with anti-MYC and anti-ubiquitin antibodies (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upper panel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). Input levels of NUDT16 and MYC are also shown (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lower panel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). (c) Western Blot shows that NUDT16 drastically decreases MYC protein levels in MOLT-16 cells treated with Actinomycin D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14 CuadroTexto"/>
          <p:cNvSpPr/>
          <p:nvPr/>
        </p:nvSpPr>
        <p:spPr>
          <a:xfrm>
            <a:off x="380520" y="314280"/>
            <a:ext cx="3819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32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15 CuadroTexto"/>
          <p:cNvSpPr/>
          <p:nvPr/>
        </p:nvSpPr>
        <p:spPr>
          <a:xfrm>
            <a:off x="3675600" y="314280"/>
            <a:ext cx="39852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32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16 CuadroTexto"/>
          <p:cNvSpPr/>
          <p:nvPr/>
        </p:nvSpPr>
        <p:spPr>
          <a:xfrm>
            <a:off x="2063520" y="5435640"/>
            <a:ext cx="3513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32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" name="Picture 2" descr=""/>
          <p:cNvPicPr/>
          <p:nvPr/>
        </p:nvPicPr>
        <p:blipFill>
          <a:blip r:embed="rId4"/>
          <a:stretch/>
        </p:blipFill>
        <p:spPr>
          <a:xfrm>
            <a:off x="4071960" y="285840"/>
            <a:ext cx="2143080" cy="4886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2-12T18:48:22Z</dcterms:created>
  <dc:creator>hferreira</dc:creator>
  <dc:description/>
  <dc:language>en-US</dc:language>
  <cp:lastModifiedBy>vidya.p</cp:lastModifiedBy>
  <dcterms:modified xsi:type="dcterms:W3CDTF">2017-04-10T10:34:56Z</dcterms:modified>
  <cp:revision>11</cp:revision>
  <dc:subject/>
  <dc:title>Diapositiva 1</dc:title>
</cp:coreProperties>
</file>